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2B04DE-E425-4ACA-BECC-43ED9E58F8F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F99FF5-4B85-4AC3-9E32-5DED2709763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6E37BC-EEC0-41F3-8B1E-8438DE8D134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6EC59-A51F-4B79-92F3-2ED46AC9CF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7021B-5306-424A-B454-8122D3E459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563D2-E23A-431E-8598-969EBE0E65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968F5-CF9F-4EF5-9C36-9530B2509E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E9953-410E-4C5A-931C-96C1EC49B3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F7E7A-C3B9-4BAC-B64C-E3A012FE12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00C66-3527-4847-91CD-F3E3B46D60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BCA2A-A11A-43E8-BFB6-EB9D8B7746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0FBD0-C6E5-4B47-8A57-16A2491D6D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C8A92-EA3F-4FFB-B600-21E2090D9B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7F4FA-CB82-4AD7-9EE3-42E953401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F45C4-E1AD-4B8D-9D70-5735C2649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255AB6-42DF-438C-BBC6-6D7B9A1A358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3"/>
          <p:cNvSpPr/>
          <p:nvPr/>
        </p:nvSpPr>
        <p:spPr>
          <a:xfrm>
            <a:off x="1395360" y="1989000"/>
            <a:ext cx="55436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Calibri"/>
              </a:rPr>
              <a:t>Additional file 8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4"/>
          <p:cNvSpPr/>
          <p:nvPr/>
        </p:nvSpPr>
        <p:spPr>
          <a:xfrm>
            <a:off x="1395360" y="2682720"/>
            <a:ext cx="66960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All the identified proteins of the non-redundant, high-confidence dataset of glomerulus proteome consisting of 1,817 unique proteins representing 1,478 unique genes were analyzed by DAVID KEGG analysis [http://david.abcc.ncifcrf.gov/] to show coverage of components comprising “REGULATION OF ACTIN CYTOSKELETON” pathway.  The 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</a:rPr>
              <a:t>Red stars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indicate matched protein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519120" y="566640"/>
            <a:ext cx="8105760" cy="5724720"/>
          </a:xfrm>
          <a:prstGeom prst="rect">
            <a:avLst/>
          </a:prstGeom>
          <a:ln w="0">
            <a:noFill/>
          </a:ln>
        </p:spPr>
      </p:pic>
      <p:sp>
        <p:nvSpPr>
          <p:cNvPr id="51" name="星 5 5"/>
          <p:cNvSpPr/>
          <p:nvPr/>
        </p:nvSpPr>
        <p:spPr>
          <a:xfrm>
            <a:off x="5002200" y="2762280"/>
            <a:ext cx="34920" cy="34920"/>
          </a:xfrm>
          <a:custGeom>
            <a:avLst/>
            <a:gdLst>
              <a:gd name="textAreaLeft" fmla="*/ 10800 w 34920"/>
              <a:gd name="textAreaRight" fmla="*/ 24120 w 3492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4925" h="34925">
                <a:moveTo>
                  <a:pt x="0" y="13340"/>
                </a:moveTo>
                <a:lnTo>
                  <a:pt x="13340" y="13340"/>
                </a:lnTo>
                <a:lnTo>
                  <a:pt x="17463" y="0"/>
                </a:lnTo>
                <a:lnTo>
                  <a:pt x="21585" y="13340"/>
                </a:lnTo>
                <a:lnTo>
                  <a:pt x="-30611" y="13340"/>
                </a:lnTo>
                <a:lnTo>
                  <a:pt x="24132" y="21585"/>
                </a:lnTo>
                <a:lnTo>
                  <a:pt x="28255" y="-30611"/>
                </a:lnTo>
                <a:lnTo>
                  <a:pt x="17463" y="26680"/>
                </a:lnTo>
                <a:lnTo>
                  <a:pt x="6670" y="-30611"/>
                </a:lnTo>
                <a:lnTo>
                  <a:pt x="1079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星 5 9"/>
          <p:cNvSpPr/>
          <p:nvPr/>
        </p:nvSpPr>
        <p:spPr>
          <a:xfrm>
            <a:off x="4834080" y="482616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星 5 14"/>
          <p:cNvSpPr/>
          <p:nvPr/>
        </p:nvSpPr>
        <p:spPr>
          <a:xfrm>
            <a:off x="1862280" y="385128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星 5 17"/>
          <p:cNvSpPr/>
          <p:nvPr/>
        </p:nvSpPr>
        <p:spPr>
          <a:xfrm>
            <a:off x="4295880" y="3357720"/>
            <a:ext cx="34920" cy="34920"/>
          </a:xfrm>
          <a:custGeom>
            <a:avLst/>
            <a:gdLst>
              <a:gd name="textAreaLeft" fmla="*/ 10800 w 34920"/>
              <a:gd name="textAreaRight" fmla="*/ 24120 w 3492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4925" h="34925">
                <a:moveTo>
                  <a:pt x="0" y="13340"/>
                </a:moveTo>
                <a:lnTo>
                  <a:pt x="13340" y="13340"/>
                </a:lnTo>
                <a:lnTo>
                  <a:pt x="17463" y="0"/>
                </a:lnTo>
                <a:lnTo>
                  <a:pt x="21585" y="13340"/>
                </a:lnTo>
                <a:lnTo>
                  <a:pt x="-30611" y="13340"/>
                </a:lnTo>
                <a:lnTo>
                  <a:pt x="24132" y="21585"/>
                </a:lnTo>
                <a:lnTo>
                  <a:pt x="28255" y="-30611"/>
                </a:lnTo>
                <a:lnTo>
                  <a:pt x="17463" y="26680"/>
                </a:lnTo>
                <a:lnTo>
                  <a:pt x="6670" y="-30611"/>
                </a:lnTo>
                <a:lnTo>
                  <a:pt x="1079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星 5 18"/>
          <p:cNvSpPr/>
          <p:nvPr/>
        </p:nvSpPr>
        <p:spPr>
          <a:xfrm>
            <a:off x="7118280" y="2736720"/>
            <a:ext cx="36720" cy="36720"/>
          </a:xfrm>
          <a:custGeom>
            <a:avLst/>
            <a:gdLst>
              <a:gd name="textAreaLeft" fmla="*/ 11160 w 36720"/>
              <a:gd name="textAreaRight" fmla="*/ 25560 w 367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3" h="36513">
                <a:moveTo>
                  <a:pt x="0" y="13947"/>
                </a:moveTo>
                <a:lnTo>
                  <a:pt x="13947" y="13947"/>
                </a:lnTo>
                <a:lnTo>
                  <a:pt x="18257" y="0"/>
                </a:lnTo>
                <a:lnTo>
                  <a:pt x="22566" y="13947"/>
                </a:lnTo>
                <a:lnTo>
                  <a:pt x="-29023" y="13947"/>
                </a:lnTo>
                <a:lnTo>
                  <a:pt x="25230" y="22566"/>
                </a:lnTo>
                <a:lnTo>
                  <a:pt x="29540" y="-29023"/>
                </a:lnTo>
                <a:lnTo>
                  <a:pt x="18257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星 5 20"/>
          <p:cNvSpPr/>
          <p:nvPr/>
        </p:nvSpPr>
        <p:spPr>
          <a:xfrm>
            <a:off x="3811680" y="1935000"/>
            <a:ext cx="36360" cy="36720"/>
          </a:xfrm>
          <a:custGeom>
            <a:avLst/>
            <a:gdLst>
              <a:gd name="textAreaLeft" fmla="*/ 11160 w 36360"/>
              <a:gd name="textAreaRight" fmla="*/ 25200 w 3636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2" h="36512">
                <a:moveTo>
                  <a:pt x="0" y="13946"/>
                </a:moveTo>
                <a:lnTo>
                  <a:pt x="13946" y="13946"/>
                </a:lnTo>
                <a:lnTo>
                  <a:pt x="18256" y="0"/>
                </a:lnTo>
                <a:lnTo>
                  <a:pt x="22566" y="13946"/>
                </a:lnTo>
                <a:lnTo>
                  <a:pt x="-29024" y="13946"/>
                </a:lnTo>
                <a:lnTo>
                  <a:pt x="25229" y="22566"/>
                </a:lnTo>
                <a:lnTo>
                  <a:pt x="29539" y="-29024"/>
                </a:lnTo>
                <a:lnTo>
                  <a:pt x="18256" y="27892"/>
                </a:lnTo>
                <a:lnTo>
                  <a:pt x="6973" y="-29024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星 5 28"/>
          <p:cNvSpPr/>
          <p:nvPr/>
        </p:nvSpPr>
        <p:spPr>
          <a:xfrm>
            <a:off x="3921120" y="5708520"/>
            <a:ext cx="36360" cy="36720"/>
          </a:xfrm>
          <a:custGeom>
            <a:avLst/>
            <a:gdLst>
              <a:gd name="textAreaLeft" fmla="*/ 11160 w 36360"/>
              <a:gd name="textAreaRight" fmla="*/ 25200 w 3636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3" h="36513">
                <a:moveTo>
                  <a:pt x="0" y="13947"/>
                </a:moveTo>
                <a:lnTo>
                  <a:pt x="13947" y="13947"/>
                </a:lnTo>
                <a:lnTo>
                  <a:pt x="18257" y="0"/>
                </a:lnTo>
                <a:lnTo>
                  <a:pt x="22566" y="13947"/>
                </a:lnTo>
                <a:lnTo>
                  <a:pt x="-29023" y="13947"/>
                </a:lnTo>
                <a:lnTo>
                  <a:pt x="25230" y="22566"/>
                </a:lnTo>
                <a:lnTo>
                  <a:pt x="29540" y="-29023"/>
                </a:lnTo>
                <a:lnTo>
                  <a:pt x="18257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星 5 29"/>
          <p:cNvSpPr/>
          <p:nvPr/>
        </p:nvSpPr>
        <p:spPr>
          <a:xfrm>
            <a:off x="4324320" y="5708520"/>
            <a:ext cx="36720" cy="36720"/>
          </a:xfrm>
          <a:custGeom>
            <a:avLst/>
            <a:gdLst>
              <a:gd name="textAreaLeft" fmla="*/ 11160 w 36720"/>
              <a:gd name="textAreaRight" fmla="*/ 25560 w 367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3" h="36513">
                <a:moveTo>
                  <a:pt x="0" y="13947"/>
                </a:moveTo>
                <a:lnTo>
                  <a:pt x="13947" y="13947"/>
                </a:lnTo>
                <a:lnTo>
                  <a:pt x="18257" y="0"/>
                </a:lnTo>
                <a:lnTo>
                  <a:pt x="22566" y="13947"/>
                </a:lnTo>
                <a:lnTo>
                  <a:pt x="-29023" y="13947"/>
                </a:lnTo>
                <a:lnTo>
                  <a:pt x="25230" y="22566"/>
                </a:lnTo>
                <a:lnTo>
                  <a:pt x="29540" y="-29023"/>
                </a:lnTo>
                <a:lnTo>
                  <a:pt x="18257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星 5 30"/>
          <p:cNvSpPr/>
          <p:nvPr/>
        </p:nvSpPr>
        <p:spPr>
          <a:xfrm>
            <a:off x="4433760" y="1071720"/>
            <a:ext cx="36720" cy="36360"/>
          </a:xfrm>
          <a:custGeom>
            <a:avLst/>
            <a:gdLst>
              <a:gd name="textAreaLeft" fmla="*/ 11160 w 36720"/>
              <a:gd name="textAreaRight" fmla="*/ 25560 w 367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2">
                <a:moveTo>
                  <a:pt x="0" y="13946"/>
                </a:moveTo>
                <a:lnTo>
                  <a:pt x="13946" y="13946"/>
                </a:lnTo>
                <a:lnTo>
                  <a:pt x="18256" y="0"/>
                </a:lnTo>
                <a:lnTo>
                  <a:pt x="22566" y="13946"/>
                </a:lnTo>
                <a:lnTo>
                  <a:pt x="-29024" y="13946"/>
                </a:lnTo>
                <a:lnTo>
                  <a:pt x="25229" y="22566"/>
                </a:lnTo>
                <a:lnTo>
                  <a:pt x="29539" y="-29024"/>
                </a:lnTo>
                <a:lnTo>
                  <a:pt x="18256" y="27892"/>
                </a:lnTo>
                <a:lnTo>
                  <a:pt x="6973" y="-29024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星 5 32"/>
          <p:cNvSpPr/>
          <p:nvPr/>
        </p:nvSpPr>
        <p:spPr>
          <a:xfrm>
            <a:off x="3827520" y="141300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星 5 33"/>
          <p:cNvSpPr/>
          <p:nvPr/>
        </p:nvSpPr>
        <p:spPr>
          <a:xfrm>
            <a:off x="4456080" y="1413000"/>
            <a:ext cx="36720" cy="36360"/>
          </a:xfrm>
          <a:custGeom>
            <a:avLst/>
            <a:gdLst>
              <a:gd name="textAreaLeft" fmla="*/ 11160 w 36720"/>
              <a:gd name="textAreaRight" fmla="*/ 25560 w 367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星 5 37"/>
          <p:cNvSpPr/>
          <p:nvPr/>
        </p:nvSpPr>
        <p:spPr>
          <a:xfrm>
            <a:off x="3087720" y="4505400"/>
            <a:ext cx="36360" cy="34920"/>
          </a:xfrm>
          <a:custGeom>
            <a:avLst/>
            <a:gdLst>
              <a:gd name="textAreaLeft" fmla="*/ 11160 w 36360"/>
              <a:gd name="textAreaRight" fmla="*/ 25200 w 3636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6512" h="34925">
                <a:moveTo>
                  <a:pt x="0" y="13340"/>
                </a:moveTo>
                <a:lnTo>
                  <a:pt x="13946" y="13340"/>
                </a:lnTo>
                <a:lnTo>
                  <a:pt x="18256" y="0"/>
                </a:lnTo>
                <a:lnTo>
                  <a:pt x="22566" y="13340"/>
                </a:lnTo>
                <a:lnTo>
                  <a:pt x="-29024" y="13340"/>
                </a:lnTo>
                <a:lnTo>
                  <a:pt x="25229" y="21585"/>
                </a:lnTo>
                <a:lnTo>
                  <a:pt x="29539" y="-30611"/>
                </a:lnTo>
                <a:lnTo>
                  <a:pt x="18256" y="26680"/>
                </a:lnTo>
                <a:lnTo>
                  <a:pt x="6973" y="-30611"/>
                </a:lnTo>
                <a:lnTo>
                  <a:pt x="1128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星 5 38"/>
          <p:cNvSpPr/>
          <p:nvPr/>
        </p:nvSpPr>
        <p:spPr>
          <a:xfrm>
            <a:off x="3294000" y="3351240"/>
            <a:ext cx="34920" cy="36360"/>
          </a:xfrm>
          <a:custGeom>
            <a:avLst/>
            <a:gdLst>
              <a:gd name="textAreaLeft" fmla="*/ 10800 w 34920"/>
              <a:gd name="textAreaRight" fmla="*/ 24120 w 349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4925" h="36512">
                <a:moveTo>
                  <a:pt x="0" y="13946"/>
                </a:moveTo>
                <a:lnTo>
                  <a:pt x="13340" y="13946"/>
                </a:lnTo>
                <a:lnTo>
                  <a:pt x="17463" y="0"/>
                </a:lnTo>
                <a:lnTo>
                  <a:pt x="21585" y="13946"/>
                </a:lnTo>
                <a:lnTo>
                  <a:pt x="-30611" y="13946"/>
                </a:lnTo>
                <a:lnTo>
                  <a:pt x="24132" y="22566"/>
                </a:lnTo>
                <a:lnTo>
                  <a:pt x="28255" y="-29024"/>
                </a:lnTo>
                <a:lnTo>
                  <a:pt x="17463" y="27892"/>
                </a:lnTo>
                <a:lnTo>
                  <a:pt x="6670" y="-29024"/>
                </a:lnTo>
                <a:lnTo>
                  <a:pt x="1079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星 5 39"/>
          <p:cNvSpPr/>
          <p:nvPr/>
        </p:nvSpPr>
        <p:spPr>
          <a:xfrm>
            <a:off x="2760840" y="2200320"/>
            <a:ext cx="34920" cy="34920"/>
          </a:xfrm>
          <a:custGeom>
            <a:avLst/>
            <a:gdLst>
              <a:gd name="textAreaLeft" fmla="*/ 10800 w 34920"/>
              <a:gd name="textAreaRight" fmla="*/ 24120 w 3492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4925" h="34925">
                <a:moveTo>
                  <a:pt x="0" y="13340"/>
                </a:moveTo>
                <a:lnTo>
                  <a:pt x="13340" y="13340"/>
                </a:lnTo>
                <a:lnTo>
                  <a:pt x="17463" y="0"/>
                </a:lnTo>
                <a:lnTo>
                  <a:pt x="21585" y="13340"/>
                </a:lnTo>
                <a:lnTo>
                  <a:pt x="-30611" y="13340"/>
                </a:lnTo>
                <a:lnTo>
                  <a:pt x="24132" y="21585"/>
                </a:lnTo>
                <a:lnTo>
                  <a:pt x="28255" y="-30611"/>
                </a:lnTo>
                <a:lnTo>
                  <a:pt x="17463" y="26680"/>
                </a:lnTo>
                <a:lnTo>
                  <a:pt x="6670" y="-30611"/>
                </a:lnTo>
                <a:lnTo>
                  <a:pt x="1079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星 5 40"/>
          <p:cNvSpPr/>
          <p:nvPr/>
        </p:nvSpPr>
        <p:spPr>
          <a:xfrm>
            <a:off x="2751120" y="2473200"/>
            <a:ext cx="34920" cy="36720"/>
          </a:xfrm>
          <a:custGeom>
            <a:avLst/>
            <a:gdLst>
              <a:gd name="textAreaLeft" fmla="*/ 10800 w 34920"/>
              <a:gd name="textAreaRight" fmla="*/ 24120 w 349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4925" h="36513">
                <a:moveTo>
                  <a:pt x="0" y="13947"/>
                </a:moveTo>
                <a:lnTo>
                  <a:pt x="13340" y="13947"/>
                </a:lnTo>
                <a:lnTo>
                  <a:pt x="17463" y="0"/>
                </a:lnTo>
                <a:lnTo>
                  <a:pt x="21585" y="13947"/>
                </a:lnTo>
                <a:lnTo>
                  <a:pt x="-30611" y="13947"/>
                </a:lnTo>
                <a:lnTo>
                  <a:pt x="24132" y="22566"/>
                </a:lnTo>
                <a:lnTo>
                  <a:pt x="28255" y="-29023"/>
                </a:lnTo>
                <a:lnTo>
                  <a:pt x="17463" y="27893"/>
                </a:lnTo>
                <a:lnTo>
                  <a:pt x="6670" y="-29023"/>
                </a:lnTo>
                <a:lnTo>
                  <a:pt x="1079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星 5 41"/>
          <p:cNvSpPr/>
          <p:nvPr/>
        </p:nvSpPr>
        <p:spPr>
          <a:xfrm>
            <a:off x="6726240" y="3763800"/>
            <a:ext cx="34920" cy="36720"/>
          </a:xfrm>
          <a:custGeom>
            <a:avLst/>
            <a:gdLst>
              <a:gd name="textAreaLeft" fmla="*/ 10800 w 34920"/>
              <a:gd name="textAreaRight" fmla="*/ 24120 w 349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4925" h="36512">
                <a:moveTo>
                  <a:pt x="0" y="13946"/>
                </a:moveTo>
                <a:lnTo>
                  <a:pt x="13340" y="13946"/>
                </a:lnTo>
                <a:lnTo>
                  <a:pt x="17463" y="0"/>
                </a:lnTo>
                <a:lnTo>
                  <a:pt x="21585" y="13946"/>
                </a:lnTo>
                <a:lnTo>
                  <a:pt x="-30611" y="13946"/>
                </a:lnTo>
                <a:lnTo>
                  <a:pt x="24132" y="22566"/>
                </a:lnTo>
                <a:lnTo>
                  <a:pt x="28255" y="-29024"/>
                </a:lnTo>
                <a:lnTo>
                  <a:pt x="17463" y="27892"/>
                </a:lnTo>
                <a:lnTo>
                  <a:pt x="6670" y="-29024"/>
                </a:lnTo>
                <a:lnTo>
                  <a:pt x="1079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星 5 44"/>
          <p:cNvSpPr/>
          <p:nvPr/>
        </p:nvSpPr>
        <p:spPr>
          <a:xfrm>
            <a:off x="2021040" y="278460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星 5 45"/>
          <p:cNvSpPr/>
          <p:nvPr/>
        </p:nvSpPr>
        <p:spPr>
          <a:xfrm>
            <a:off x="1727280" y="576900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3" h="36513">
                <a:moveTo>
                  <a:pt x="0" y="13947"/>
                </a:moveTo>
                <a:lnTo>
                  <a:pt x="13947" y="13947"/>
                </a:lnTo>
                <a:lnTo>
                  <a:pt x="18257" y="0"/>
                </a:lnTo>
                <a:lnTo>
                  <a:pt x="22566" y="13947"/>
                </a:lnTo>
                <a:lnTo>
                  <a:pt x="-29023" y="13947"/>
                </a:lnTo>
                <a:lnTo>
                  <a:pt x="25230" y="22566"/>
                </a:lnTo>
                <a:lnTo>
                  <a:pt x="29540" y="-29023"/>
                </a:lnTo>
                <a:lnTo>
                  <a:pt x="18257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星 5 46"/>
          <p:cNvSpPr/>
          <p:nvPr/>
        </p:nvSpPr>
        <p:spPr>
          <a:xfrm>
            <a:off x="2411280" y="6021360"/>
            <a:ext cx="36720" cy="36720"/>
          </a:xfrm>
          <a:custGeom>
            <a:avLst/>
            <a:gdLst>
              <a:gd name="textAreaLeft" fmla="*/ 11160 w 36720"/>
              <a:gd name="textAreaRight" fmla="*/ 25560 w 367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2" h="36512">
                <a:moveTo>
                  <a:pt x="0" y="13946"/>
                </a:moveTo>
                <a:lnTo>
                  <a:pt x="13946" y="13946"/>
                </a:lnTo>
                <a:lnTo>
                  <a:pt x="18256" y="0"/>
                </a:lnTo>
                <a:lnTo>
                  <a:pt x="22566" y="13946"/>
                </a:lnTo>
                <a:lnTo>
                  <a:pt x="-29024" y="13946"/>
                </a:lnTo>
                <a:lnTo>
                  <a:pt x="25229" y="22566"/>
                </a:lnTo>
                <a:lnTo>
                  <a:pt x="29539" y="-29024"/>
                </a:lnTo>
                <a:lnTo>
                  <a:pt x="18256" y="27892"/>
                </a:lnTo>
                <a:lnTo>
                  <a:pt x="6973" y="-29024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星 5 47"/>
          <p:cNvSpPr/>
          <p:nvPr/>
        </p:nvSpPr>
        <p:spPr>
          <a:xfrm>
            <a:off x="3290760" y="5003640"/>
            <a:ext cx="36720" cy="36720"/>
          </a:xfrm>
          <a:custGeom>
            <a:avLst/>
            <a:gdLst>
              <a:gd name="textAreaLeft" fmla="*/ 11160 w 36720"/>
              <a:gd name="textAreaRight" fmla="*/ 25560 w 367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星 5 48"/>
          <p:cNvSpPr/>
          <p:nvPr/>
        </p:nvSpPr>
        <p:spPr>
          <a:xfrm>
            <a:off x="2598840" y="4932360"/>
            <a:ext cx="36360" cy="34920"/>
          </a:xfrm>
          <a:custGeom>
            <a:avLst/>
            <a:gdLst>
              <a:gd name="textAreaLeft" fmla="*/ 11160 w 36360"/>
              <a:gd name="textAreaRight" fmla="*/ 25200 w 3636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6512" h="34925">
                <a:moveTo>
                  <a:pt x="0" y="13340"/>
                </a:moveTo>
                <a:lnTo>
                  <a:pt x="13946" y="13340"/>
                </a:lnTo>
                <a:lnTo>
                  <a:pt x="18256" y="0"/>
                </a:lnTo>
                <a:lnTo>
                  <a:pt x="22566" y="13340"/>
                </a:lnTo>
                <a:lnTo>
                  <a:pt x="-29024" y="13340"/>
                </a:lnTo>
                <a:lnTo>
                  <a:pt x="25229" y="21585"/>
                </a:lnTo>
                <a:lnTo>
                  <a:pt x="29539" y="-30611"/>
                </a:lnTo>
                <a:lnTo>
                  <a:pt x="18256" y="26680"/>
                </a:lnTo>
                <a:lnTo>
                  <a:pt x="6973" y="-30611"/>
                </a:lnTo>
                <a:lnTo>
                  <a:pt x="1128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星 5 50"/>
          <p:cNvSpPr/>
          <p:nvPr/>
        </p:nvSpPr>
        <p:spPr>
          <a:xfrm>
            <a:off x="1593720" y="4014720"/>
            <a:ext cx="34920" cy="36720"/>
          </a:xfrm>
          <a:custGeom>
            <a:avLst/>
            <a:gdLst>
              <a:gd name="textAreaLeft" fmla="*/ 10800 w 34920"/>
              <a:gd name="textAreaRight" fmla="*/ 24120 w 34920"/>
              <a:gd name="textAreaTop" fmla="*/ 14040 h 36720"/>
              <a:gd name="textAreaBottom" fmla="*/ 28080 h 36720"/>
            </a:gdLst>
            <a:ahLst/>
            <a:rect l="textAreaLeft" t="textAreaTop" r="textAreaRight" b="textAreaBottom"/>
            <a:pathLst>
              <a:path w="34925" h="36512">
                <a:moveTo>
                  <a:pt x="0" y="13946"/>
                </a:moveTo>
                <a:lnTo>
                  <a:pt x="13340" y="13946"/>
                </a:lnTo>
                <a:lnTo>
                  <a:pt x="17463" y="0"/>
                </a:lnTo>
                <a:lnTo>
                  <a:pt x="21585" y="13946"/>
                </a:lnTo>
                <a:lnTo>
                  <a:pt x="-30611" y="13946"/>
                </a:lnTo>
                <a:lnTo>
                  <a:pt x="24132" y="22566"/>
                </a:lnTo>
                <a:lnTo>
                  <a:pt x="28255" y="-29024"/>
                </a:lnTo>
                <a:lnTo>
                  <a:pt x="17463" y="27892"/>
                </a:lnTo>
                <a:lnTo>
                  <a:pt x="6670" y="-29024"/>
                </a:lnTo>
                <a:lnTo>
                  <a:pt x="1079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星 5 31"/>
          <p:cNvSpPr/>
          <p:nvPr/>
        </p:nvSpPr>
        <p:spPr>
          <a:xfrm>
            <a:off x="7267680" y="4324320"/>
            <a:ext cx="34920" cy="34920"/>
          </a:xfrm>
          <a:custGeom>
            <a:avLst/>
            <a:gdLst>
              <a:gd name="textAreaLeft" fmla="*/ 10800 w 34920"/>
              <a:gd name="textAreaRight" fmla="*/ 24120 w 3492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4925" h="34925">
                <a:moveTo>
                  <a:pt x="0" y="13340"/>
                </a:moveTo>
                <a:lnTo>
                  <a:pt x="13340" y="13340"/>
                </a:lnTo>
                <a:lnTo>
                  <a:pt x="17463" y="0"/>
                </a:lnTo>
                <a:lnTo>
                  <a:pt x="21585" y="13340"/>
                </a:lnTo>
                <a:lnTo>
                  <a:pt x="-30611" y="13340"/>
                </a:lnTo>
                <a:lnTo>
                  <a:pt x="24132" y="21585"/>
                </a:lnTo>
                <a:lnTo>
                  <a:pt x="28255" y="-30611"/>
                </a:lnTo>
                <a:lnTo>
                  <a:pt x="17463" y="26680"/>
                </a:lnTo>
                <a:lnTo>
                  <a:pt x="6670" y="-30611"/>
                </a:lnTo>
                <a:lnTo>
                  <a:pt x="1079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星 5 35"/>
          <p:cNvSpPr/>
          <p:nvPr/>
        </p:nvSpPr>
        <p:spPr>
          <a:xfrm>
            <a:off x="6948360" y="4689360"/>
            <a:ext cx="36720" cy="34920"/>
          </a:xfrm>
          <a:custGeom>
            <a:avLst/>
            <a:gdLst>
              <a:gd name="textAreaLeft" fmla="*/ 11160 w 36720"/>
              <a:gd name="textAreaRight" fmla="*/ 25560 w 36720"/>
              <a:gd name="textAreaTop" fmla="*/ 13320 h 34920"/>
              <a:gd name="textAreaBottom" fmla="*/ 26640 h 34920"/>
            </a:gdLst>
            <a:ahLst/>
            <a:rect l="textAreaLeft" t="textAreaTop" r="textAreaRight" b="textAreaBottom"/>
            <a:pathLst>
              <a:path w="36512" h="34925">
                <a:moveTo>
                  <a:pt x="0" y="13340"/>
                </a:moveTo>
                <a:lnTo>
                  <a:pt x="13946" y="13340"/>
                </a:lnTo>
                <a:lnTo>
                  <a:pt x="18256" y="0"/>
                </a:lnTo>
                <a:lnTo>
                  <a:pt x="22566" y="13340"/>
                </a:lnTo>
                <a:lnTo>
                  <a:pt x="-29024" y="13340"/>
                </a:lnTo>
                <a:lnTo>
                  <a:pt x="25229" y="21585"/>
                </a:lnTo>
                <a:lnTo>
                  <a:pt x="29539" y="-30611"/>
                </a:lnTo>
                <a:lnTo>
                  <a:pt x="18256" y="26680"/>
                </a:lnTo>
                <a:lnTo>
                  <a:pt x="6973" y="-30611"/>
                </a:lnTo>
                <a:lnTo>
                  <a:pt x="11283" y="21585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480" bIns="-33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星 5 52"/>
          <p:cNvSpPr/>
          <p:nvPr/>
        </p:nvSpPr>
        <p:spPr>
          <a:xfrm>
            <a:off x="7677000" y="2706840"/>
            <a:ext cx="36720" cy="36360"/>
          </a:xfrm>
          <a:custGeom>
            <a:avLst/>
            <a:gdLst>
              <a:gd name="textAreaLeft" fmla="*/ 11160 w 36720"/>
              <a:gd name="textAreaRight" fmla="*/ 25560 w 367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3" h="36512">
                <a:moveTo>
                  <a:pt x="0" y="13946"/>
                </a:moveTo>
                <a:lnTo>
                  <a:pt x="13947" y="13946"/>
                </a:lnTo>
                <a:lnTo>
                  <a:pt x="18257" y="0"/>
                </a:lnTo>
                <a:lnTo>
                  <a:pt x="22566" y="13946"/>
                </a:lnTo>
                <a:lnTo>
                  <a:pt x="-29023" y="13946"/>
                </a:lnTo>
                <a:lnTo>
                  <a:pt x="25230" y="22566"/>
                </a:lnTo>
                <a:lnTo>
                  <a:pt x="29540" y="-29024"/>
                </a:lnTo>
                <a:lnTo>
                  <a:pt x="18257" y="27892"/>
                </a:lnTo>
                <a:lnTo>
                  <a:pt x="6973" y="-29024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星 5 53"/>
          <p:cNvSpPr/>
          <p:nvPr/>
        </p:nvSpPr>
        <p:spPr>
          <a:xfrm>
            <a:off x="5025960" y="1692360"/>
            <a:ext cx="36720" cy="36360"/>
          </a:xfrm>
          <a:custGeom>
            <a:avLst/>
            <a:gdLst>
              <a:gd name="textAreaLeft" fmla="*/ 11160 w 36720"/>
              <a:gd name="textAreaRight" fmla="*/ 25560 w 367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3" h="36513">
                <a:moveTo>
                  <a:pt x="0" y="13947"/>
                </a:moveTo>
                <a:lnTo>
                  <a:pt x="13947" y="13947"/>
                </a:lnTo>
                <a:lnTo>
                  <a:pt x="18257" y="0"/>
                </a:lnTo>
                <a:lnTo>
                  <a:pt x="22566" y="13947"/>
                </a:lnTo>
                <a:lnTo>
                  <a:pt x="-29023" y="13947"/>
                </a:lnTo>
                <a:lnTo>
                  <a:pt x="25230" y="22566"/>
                </a:lnTo>
                <a:lnTo>
                  <a:pt x="29540" y="-29023"/>
                </a:lnTo>
                <a:lnTo>
                  <a:pt x="18257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星 5 54"/>
          <p:cNvSpPr/>
          <p:nvPr/>
        </p:nvSpPr>
        <p:spPr>
          <a:xfrm>
            <a:off x="4586400" y="1901880"/>
            <a:ext cx="36360" cy="36360"/>
          </a:xfrm>
          <a:custGeom>
            <a:avLst/>
            <a:gdLst>
              <a:gd name="textAreaLeft" fmla="*/ 11160 w 36360"/>
              <a:gd name="textAreaRight" fmla="*/ 25200 w 3636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6512" h="36513">
                <a:moveTo>
                  <a:pt x="0" y="13947"/>
                </a:moveTo>
                <a:lnTo>
                  <a:pt x="13946" y="13947"/>
                </a:lnTo>
                <a:lnTo>
                  <a:pt x="18256" y="0"/>
                </a:lnTo>
                <a:lnTo>
                  <a:pt x="22566" y="13947"/>
                </a:lnTo>
                <a:lnTo>
                  <a:pt x="-29024" y="13947"/>
                </a:lnTo>
                <a:lnTo>
                  <a:pt x="25229" y="22566"/>
                </a:lnTo>
                <a:lnTo>
                  <a:pt x="29539" y="-29023"/>
                </a:lnTo>
                <a:lnTo>
                  <a:pt x="18256" y="27893"/>
                </a:lnTo>
                <a:lnTo>
                  <a:pt x="6973" y="-29023"/>
                </a:lnTo>
                <a:lnTo>
                  <a:pt x="1128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星 5 55"/>
          <p:cNvSpPr/>
          <p:nvPr/>
        </p:nvSpPr>
        <p:spPr>
          <a:xfrm>
            <a:off x="1593720" y="4176720"/>
            <a:ext cx="34920" cy="36360"/>
          </a:xfrm>
          <a:custGeom>
            <a:avLst/>
            <a:gdLst>
              <a:gd name="textAreaLeft" fmla="*/ 10800 w 34920"/>
              <a:gd name="textAreaRight" fmla="*/ 24120 w 34920"/>
              <a:gd name="textAreaTop" fmla="*/ 13680 h 36360"/>
              <a:gd name="textAreaBottom" fmla="*/ 27720 h 36360"/>
            </a:gdLst>
            <a:ahLst/>
            <a:rect l="textAreaLeft" t="textAreaTop" r="textAreaRight" b="textAreaBottom"/>
            <a:pathLst>
              <a:path w="34925" h="36512">
                <a:moveTo>
                  <a:pt x="0" y="13946"/>
                </a:moveTo>
                <a:lnTo>
                  <a:pt x="13340" y="13946"/>
                </a:lnTo>
                <a:lnTo>
                  <a:pt x="17463" y="0"/>
                </a:lnTo>
                <a:lnTo>
                  <a:pt x="21585" y="13946"/>
                </a:lnTo>
                <a:lnTo>
                  <a:pt x="-30611" y="13946"/>
                </a:lnTo>
                <a:lnTo>
                  <a:pt x="24132" y="22566"/>
                </a:lnTo>
                <a:lnTo>
                  <a:pt x="28255" y="-29024"/>
                </a:lnTo>
                <a:lnTo>
                  <a:pt x="17463" y="27892"/>
                </a:lnTo>
                <a:lnTo>
                  <a:pt x="6670" y="-29024"/>
                </a:lnTo>
                <a:lnTo>
                  <a:pt x="10793" y="22566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34"/>
          <p:cNvSpPr/>
          <p:nvPr/>
        </p:nvSpPr>
        <p:spPr>
          <a:xfrm>
            <a:off x="6353280" y="6443640"/>
            <a:ext cx="273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8 Cui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8T07:37:23Z</dcterms:created>
  <dc:creator>Yutaka Yoshida</dc:creator>
  <dc:description/>
  <dc:language>en-US</dc:language>
  <cp:lastModifiedBy>Yutaka Yoshida</cp:lastModifiedBy>
  <dcterms:modified xsi:type="dcterms:W3CDTF">2013-03-27T02:52:55Z</dcterms:modified>
  <cp:revision>7</cp:revision>
  <dc:subject/>
  <dc:title>スライド 1</dc:title>
</cp:coreProperties>
</file>